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59" r:id="rId2"/>
    <p:sldId id="261" r:id="rId3"/>
    <p:sldId id="262" r:id="rId4"/>
  </p:sldIdLst>
  <p:sldSz cx="6858000" cy="12192000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9" d="100"/>
          <a:sy n="69" d="100"/>
        </p:scale>
        <p:origin x="328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8ED3D1F-44F8-4577-AA92-83BA447D5D9F}" type="datetimeFigureOut">
              <a:rPr lang="en-AU" smtClean="0"/>
              <a:t>11/04/2019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57450" y="1241425"/>
            <a:ext cx="188277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E134569-3F34-48E6-A477-3D9FF4C0057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152411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90BA06-A501-421A-A0FC-A49FF24B399B}" type="datetimeFigureOut">
              <a:rPr lang="en-AU" smtClean="0"/>
              <a:t>11/04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C974FA-A0F0-4E4E-8AFD-75438EF3D00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566720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90BA06-A501-421A-A0FC-A49FF24B399B}" type="datetimeFigureOut">
              <a:rPr lang="en-AU" smtClean="0"/>
              <a:t>11/04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C974FA-A0F0-4E4E-8AFD-75438EF3D00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777503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90BA06-A501-421A-A0FC-A49FF24B399B}" type="datetimeFigureOut">
              <a:rPr lang="en-AU" smtClean="0"/>
              <a:t>11/04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C974FA-A0F0-4E4E-8AFD-75438EF3D00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874682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90BA06-A501-421A-A0FC-A49FF24B399B}" type="datetimeFigureOut">
              <a:rPr lang="en-AU" smtClean="0"/>
              <a:t>11/04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C974FA-A0F0-4E4E-8AFD-75438EF3D00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171315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90BA06-A501-421A-A0FC-A49FF24B399B}" type="datetimeFigureOut">
              <a:rPr lang="en-AU" smtClean="0"/>
              <a:t>11/04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C974FA-A0F0-4E4E-8AFD-75438EF3D00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49836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90BA06-A501-421A-A0FC-A49FF24B399B}" type="datetimeFigureOut">
              <a:rPr lang="en-AU" smtClean="0"/>
              <a:t>11/04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C974FA-A0F0-4E4E-8AFD-75438EF3D00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606355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90BA06-A501-421A-A0FC-A49FF24B399B}" type="datetimeFigureOut">
              <a:rPr lang="en-AU" smtClean="0"/>
              <a:t>11/04/2019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C974FA-A0F0-4E4E-8AFD-75438EF3D00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494058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90BA06-A501-421A-A0FC-A49FF24B399B}" type="datetimeFigureOut">
              <a:rPr lang="en-AU" smtClean="0"/>
              <a:t>11/04/2019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C974FA-A0F0-4E4E-8AFD-75438EF3D00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352882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90BA06-A501-421A-A0FC-A49FF24B399B}" type="datetimeFigureOut">
              <a:rPr lang="en-AU" smtClean="0"/>
              <a:t>11/04/2019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C974FA-A0F0-4E4E-8AFD-75438EF3D00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160771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90BA06-A501-421A-A0FC-A49FF24B399B}" type="datetimeFigureOut">
              <a:rPr lang="en-AU" smtClean="0"/>
              <a:t>11/04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C974FA-A0F0-4E4E-8AFD-75438EF3D00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635392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90BA06-A501-421A-A0FC-A49FF24B399B}" type="datetimeFigureOut">
              <a:rPr lang="en-AU" smtClean="0"/>
              <a:t>11/04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C974FA-A0F0-4E4E-8AFD-75438EF3D00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948286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90BA06-A501-421A-A0FC-A49FF24B399B}" type="datetimeFigureOut">
              <a:rPr lang="en-AU" smtClean="0"/>
              <a:t>11/04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C974FA-A0F0-4E4E-8AFD-75438EF3D00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114501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" name="Straight Connector 3"/>
          <p:cNvCxnSpPr/>
          <p:nvPr/>
        </p:nvCxnSpPr>
        <p:spPr>
          <a:xfrm flipV="1">
            <a:off x="677668" y="1164161"/>
            <a:ext cx="4659741" cy="3600"/>
          </a:xfrm>
          <a:prstGeom prst="line">
            <a:avLst/>
          </a:prstGeom>
          <a:solidFill>
            <a:schemeClr val="bg1"/>
          </a:solidFill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/>
          <p:cNvSpPr txBox="1"/>
          <p:nvPr/>
        </p:nvSpPr>
        <p:spPr>
          <a:xfrm>
            <a:off x="3262088" y="617638"/>
            <a:ext cx="56021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675nt</a:t>
            </a:r>
            <a:endParaRPr lang="en-AU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Left Arrow 7"/>
          <p:cNvSpPr/>
          <p:nvPr/>
        </p:nvSpPr>
        <p:spPr>
          <a:xfrm>
            <a:off x="628533" y="991380"/>
            <a:ext cx="2553340" cy="357674"/>
          </a:xfrm>
          <a:prstGeom prst="lef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ga_SF370: 1587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Left Arrow 9"/>
          <p:cNvSpPr/>
          <p:nvPr/>
        </p:nvSpPr>
        <p:spPr>
          <a:xfrm>
            <a:off x="3849343" y="972692"/>
            <a:ext cx="1537201" cy="365448"/>
          </a:xfrm>
          <a:prstGeom prst="lef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py2023: 249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5" name="Straight Connector 14"/>
          <p:cNvCxnSpPr/>
          <p:nvPr/>
        </p:nvCxnSpPr>
        <p:spPr>
          <a:xfrm flipV="1">
            <a:off x="648096" y="1991563"/>
            <a:ext cx="4659741" cy="3600"/>
          </a:xfrm>
          <a:prstGeom prst="line">
            <a:avLst/>
          </a:prstGeom>
          <a:solidFill>
            <a:schemeClr val="bg1"/>
          </a:solidFill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Left Arrow 17"/>
          <p:cNvSpPr/>
          <p:nvPr/>
        </p:nvSpPr>
        <p:spPr>
          <a:xfrm>
            <a:off x="626881" y="1791534"/>
            <a:ext cx="1623514" cy="391413"/>
          </a:xfrm>
          <a:prstGeom prst="lef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ofA_SF370: 1491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Right Arrow 22"/>
          <p:cNvSpPr/>
          <p:nvPr/>
        </p:nvSpPr>
        <p:spPr>
          <a:xfrm>
            <a:off x="3657652" y="1777679"/>
            <a:ext cx="1824380" cy="405268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p1_spy0125 : 2268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2606854" y="1463045"/>
            <a:ext cx="56021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262nt</a:t>
            </a:r>
            <a:endParaRPr lang="en-AU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0" name="Straight Connector 29"/>
          <p:cNvCxnSpPr/>
          <p:nvPr/>
        </p:nvCxnSpPr>
        <p:spPr>
          <a:xfrm flipV="1">
            <a:off x="647958" y="3400803"/>
            <a:ext cx="4659741" cy="3600"/>
          </a:xfrm>
          <a:prstGeom prst="line">
            <a:avLst/>
          </a:prstGeom>
          <a:solidFill>
            <a:schemeClr val="bg1"/>
          </a:solidFill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Left Arrow 30"/>
          <p:cNvSpPr/>
          <p:nvPr/>
        </p:nvSpPr>
        <p:spPr>
          <a:xfrm>
            <a:off x="632676" y="3215289"/>
            <a:ext cx="1821978" cy="359766"/>
          </a:xfrm>
          <a:prstGeom prst="lef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lp3_SF370: 885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Right Arrow 32"/>
          <p:cNvSpPr/>
          <p:nvPr/>
        </p:nvSpPr>
        <p:spPr>
          <a:xfrm>
            <a:off x="3439145" y="3211770"/>
            <a:ext cx="2031581" cy="342000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pf_spy0737 : 6135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2601866" y="2955823"/>
            <a:ext cx="805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13 </a:t>
            </a:r>
            <a:r>
              <a:rPr lang="en-AU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5" name="Straight Connector 34"/>
          <p:cNvCxnSpPr/>
          <p:nvPr/>
        </p:nvCxnSpPr>
        <p:spPr>
          <a:xfrm flipV="1">
            <a:off x="838612" y="4181897"/>
            <a:ext cx="4659741" cy="3600"/>
          </a:xfrm>
          <a:prstGeom prst="line">
            <a:avLst/>
          </a:prstGeom>
          <a:solidFill>
            <a:schemeClr val="bg1"/>
          </a:solidFill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Left Arrow 35"/>
          <p:cNvSpPr/>
          <p:nvPr/>
        </p:nvSpPr>
        <p:spPr>
          <a:xfrm>
            <a:off x="484337" y="3996942"/>
            <a:ext cx="1915192" cy="342000"/>
          </a:xfrm>
          <a:prstGeom prst="lef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ivR_SF370: 1506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Right Arrow 37"/>
          <p:cNvSpPr/>
          <p:nvPr/>
        </p:nvSpPr>
        <p:spPr>
          <a:xfrm>
            <a:off x="2850775" y="3996941"/>
            <a:ext cx="3307154" cy="341689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ransposase-like element_spy0217: 702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2341427" y="3760001"/>
            <a:ext cx="805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554 </a:t>
            </a:r>
            <a:r>
              <a:rPr lang="en-AU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0" name="Straight Connector 39"/>
          <p:cNvCxnSpPr/>
          <p:nvPr/>
        </p:nvCxnSpPr>
        <p:spPr>
          <a:xfrm flipV="1">
            <a:off x="636790" y="2796375"/>
            <a:ext cx="4659741" cy="3600"/>
          </a:xfrm>
          <a:prstGeom prst="line">
            <a:avLst/>
          </a:prstGeom>
          <a:solidFill>
            <a:schemeClr val="bg1"/>
          </a:solidFill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Left Arrow 40"/>
          <p:cNvSpPr/>
          <p:nvPr/>
        </p:nvSpPr>
        <p:spPr>
          <a:xfrm>
            <a:off x="615574" y="2596346"/>
            <a:ext cx="1991279" cy="391413"/>
          </a:xfrm>
          <a:prstGeom prst="lef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</a:t>
            </a:r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MGAS315: 1533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Right Arrow 41"/>
          <p:cNvSpPr/>
          <p:nvPr/>
        </p:nvSpPr>
        <p:spPr>
          <a:xfrm>
            <a:off x="3262088" y="2582491"/>
            <a:ext cx="2208638" cy="405268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</a:t>
            </a:r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spyM3_0098: 2232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2637666" y="2442603"/>
            <a:ext cx="830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29 </a:t>
            </a:r>
            <a:r>
              <a:rPr lang="en-AU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5" name="Straight Connector 24"/>
          <p:cNvCxnSpPr/>
          <p:nvPr/>
        </p:nvCxnSpPr>
        <p:spPr>
          <a:xfrm flipV="1">
            <a:off x="721360" y="6022955"/>
            <a:ext cx="4659741" cy="3600"/>
          </a:xfrm>
          <a:prstGeom prst="line">
            <a:avLst/>
          </a:prstGeom>
          <a:solidFill>
            <a:schemeClr val="bg1"/>
          </a:solidFill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Right Arrow 27"/>
          <p:cNvSpPr/>
          <p:nvPr/>
        </p:nvSpPr>
        <p:spPr>
          <a:xfrm>
            <a:off x="3170521" y="5809071"/>
            <a:ext cx="2384775" cy="405268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ropB_spy2042_SF370: 840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2399529" y="5586540"/>
            <a:ext cx="805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268 </a:t>
            </a:r>
            <a:r>
              <a:rPr lang="en-AU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7" name="Straight Connector 36"/>
          <p:cNvCxnSpPr/>
          <p:nvPr/>
        </p:nvCxnSpPr>
        <p:spPr>
          <a:xfrm flipV="1">
            <a:off x="783040" y="8403186"/>
            <a:ext cx="4659741" cy="3600"/>
          </a:xfrm>
          <a:prstGeom prst="line">
            <a:avLst/>
          </a:prstGeom>
          <a:solidFill>
            <a:schemeClr val="bg1"/>
          </a:solidFill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Right Arrow 44"/>
          <p:cNvSpPr/>
          <p:nvPr/>
        </p:nvSpPr>
        <p:spPr>
          <a:xfrm>
            <a:off x="3792596" y="8189302"/>
            <a:ext cx="1824380" cy="405268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comR_SF370: 909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Right Arrow 45"/>
          <p:cNvSpPr/>
          <p:nvPr/>
        </p:nvSpPr>
        <p:spPr>
          <a:xfrm>
            <a:off x="744828" y="8193792"/>
            <a:ext cx="1824380" cy="405268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urB_spy0036_: 1290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2710291" y="7966771"/>
            <a:ext cx="805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31 </a:t>
            </a:r>
            <a:r>
              <a:rPr lang="en-AU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8" name="Straight Connector 47"/>
          <p:cNvCxnSpPr/>
          <p:nvPr/>
        </p:nvCxnSpPr>
        <p:spPr>
          <a:xfrm flipV="1">
            <a:off x="748184" y="6698419"/>
            <a:ext cx="4659741" cy="3600"/>
          </a:xfrm>
          <a:prstGeom prst="line">
            <a:avLst/>
          </a:prstGeom>
          <a:solidFill>
            <a:schemeClr val="bg1"/>
          </a:solidFill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Left Arrow 48"/>
          <p:cNvSpPr/>
          <p:nvPr/>
        </p:nvSpPr>
        <p:spPr>
          <a:xfrm>
            <a:off x="747416" y="6527419"/>
            <a:ext cx="1333186" cy="346939"/>
          </a:xfrm>
          <a:prstGeom prst="lef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HP2 : 66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Right Arrow 49"/>
          <p:cNvSpPr/>
          <p:nvPr/>
        </p:nvSpPr>
        <p:spPr>
          <a:xfrm>
            <a:off x="3295495" y="6509385"/>
            <a:ext cx="2275457" cy="427427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gg2_spy0496_SF370: 864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2349094" y="6327600"/>
            <a:ext cx="805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8 </a:t>
            </a:r>
            <a:r>
              <a:rPr lang="en-AU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2" name="Straight Connector 51"/>
          <p:cNvCxnSpPr/>
          <p:nvPr/>
        </p:nvCxnSpPr>
        <p:spPr>
          <a:xfrm flipV="1">
            <a:off x="653491" y="7461764"/>
            <a:ext cx="4659741" cy="3600"/>
          </a:xfrm>
          <a:prstGeom prst="line">
            <a:avLst/>
          </a:prstGeom>
          <a:solidFill>
            <a:schemeClr val="bg1"/>
          </a:solidFill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Left Arrow 52"/>
          <p:cNvSpPr/>
          <p:nvPr/>
        </p:nvSpPr>
        <p:spPr>
          <a:xfrm>
            <a:off x="652723" y="7261736"/>
            <a:ext cx="2330638" cy="395600"/>
          </a:xfrm>
          <a:prstGeom prst="lef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gg3_spy0533_SF370: 849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Right Arrow 53"/>
          <p:cNvSpPr/>
          <p:nvPr/>
        </p:nvSpPr>
        <p:spPr>
          <a:xfrm>
            <a:off x="4144106" y="7268909"/>
            <a:ext cx="1194854" cy="365537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HP3: 78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3357443" y="7076635"/>
            <a:ext cx="805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 </a:t>
            </a:r>
            <a:r>
              <a:rPr lang="en-AU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7" name="Straight Connector 56"/>
          <p:cNvCxnSpPr/>
          <p:nvPr/>
        </p:nvCxnSpPr>
        <p:spPr>
          <a:xfrm flipV="1">
            <a:off x="748855" y="5104847"/>
            <a:ext cx="4659741" cy="3600"/>
          </a:xfrm>
          <a:prstGeom prst="line">
            <a:avLst/>
          </a:prstGeom>
          <a:solidFill>
            <a:schemeClr val="bg1"/>
          </a:solidFill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Left Arrow 57"/>
          <p:cNvSpPr/>
          <p:nvPr/>
        </p:nvSpPr>
        <p:spPr>
          <a:xfrm>
            <a:off x="484337" y="4936866"/>
            <a:ext cx="2477213" cy="394550"/>
          </a:xfrm>
          <a:prstGeom prst="lef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smR_spy_490118: 1203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Right Arrow 58"/>
          <p:cNvSpPr/>
          <p:nvPr/>
        </p:nvSpPr>
        <p:spPr>
          <a:xfrm>
            <a:off x="3738518" y="4930145"/>
            <a:ext cx="2031581" cy="342000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tF2_NZ131: 3480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3007859" y="4674303"/>
            <a:ext cx="805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384 </a:t>
            </a:r>
            <a:r>
              <a:rPr lang="en-AU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Left Arrow 60"/>
          <p:cNvSpPr/>
          <p:nvPr/>
        </p:nvSpPr>
        <p:spPr>
          <a:xfrm>
            <a:off x="612219" y="5809071"/>
            <a:ext cx="1621805" cy="391503"/>
          </a:xfrm>
          <a:prstGeom prst="lef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SIP (orf1): 24 </a:t>
            </a:r>
            <a:r>
              <a:rPr lang="en-AU" sz="12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2" name="Straight Connector 71"/>
          <p:cNvCxnSpPr/>
          <p:nvPr/>
        </p:nvCxnSpPr>
        <p:spPr>
          <a:xfrm flipV="1">
            <a:off x="749554" y="9214729"/>
            <a:ext cx="4659741" cy="3600"/>
          </a:xfrm>
          <a:prstGeom prst="line">
            <a:avLst/>
          </a:prstGeom>
          <a:solidFill>
            <a:schemeClr val="bg1"/>
          </a:solidFill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TextBox 72"/>
          <p:cNvSpPr txBox="1"/>
          <p:nvPr/>
        </p:nvSpPr>
        <p:spPr>
          <a:xfrm>
            <a:off x="2781956" y="8795949"/>
            <a:ext cx="7155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17 </a:t>
            </a:r>
            <a:r>
              <a:rPr lang="en-AU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Left Arrow 73"/>
          <p:cNvSpPr/>
          <p:nvPr/>
        </p:nvSpPr>
        <p:spPr>
          <a:xfrm>
            <a:off x="700419" y="9041948"/>
            <a:ext cx="2200438" cy="357674"/>
          </a:xfrm>
          <a:prstGeom prst="lef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dY_spy1777_SF370: 780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Left Arrow 74"/>
          <p:cNvSpPr/>
          <p:nvPr/>
        </p:nvSpPr>
        <p:spPr>
          <a:xfrm>
            <a:off x="3193136" y="9023260"/>
            <a:ext cx="2700721" cy="365448"/>
          </a:xfrm>
          <a:prstGeom prst="lef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spartate aminotransferase :  1212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6" name="Straight Connector 75"/>
          <p:cNvCxnSpPr/>
          <p:nvPr/>
        </p:nvCxnSpPr>
        <p:spPr>
          <a:xfrm flipV="1">
            <a:off x="701187" y="10077563"/>
            <a:ext cx="4659741" cy="3600"/>
          </a:xfrm>
          <a:prstGeom prst="line">
            <a:avLst/>
          </a:prstGeom>
          <a:solidFill>
            <a:schemeClr val="bg1"/>
          </a:solidFill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Left Arrow 76"/>
          <p:cNvSpPr/>
          <p:nvPr/>
        </p:nvSpPr>
        <p:spPr>
          <a:xfrm>
            <a:off x="700419" y="9906563"/>
            <a:ext cx="1821978" cy="359766"/>
          </a:xfrm>
          <a:prstGeom prst="lef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epQ_spy0513: 1083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Right Arrow 77"/>
          <p:cNvSpPr/>
          <p:nvPr/>
        </p:nvSpPr>
        <p:spPr>
          <a:xfrm>
            <a:off x="3492374" y="9888529"/>
            <a:ext cx="2031581" cy="377799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cpA_SF370: 999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2701213" y="9647019"/>
            <a:ext cx="805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173 </a:t>
            </a:r>
            <a:r>
              <a:rPr lang="en-AU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0" name="Straight Connector 79"/>
          <p:cNvCxnSpPr/>
          <p:nvPr/>
        </p:nvCxnSpPr>
        <p:spPr>
          <a:xfrm flipV="1">
            <a:off x="772396" y="10768788"/>
            <a:ext cx="4659741" cy="3600"/>
          </a:xfrm>
          <a:prstGeom prst="line">
            <a:avLst/>
          </a:prstGeom>
          <a:solidFill>
            <a:schemeClr val="bg1"/>
          </a:solidFill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Left Arrow 80"/>
          <p:cNvSpPr/>
          <p:nvPr/>
        </p:nvSpPr>
        <p:spPr>
          <a:xfrm>
            <a:off x="771627" y="10597788"/>
            <a:ext cx="2290817" cy="359766"/>
          </a:xfrm>
          <a:prstGeom prst="lef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tsR_spy0450_SF370: 645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Right Arrow 81"/>
          <p:cNvSpPr/>
          <p:nvPr/>
        </p:nvSpPr>
        <p:spPr>
          <a:xfrm>
            <a:off x="3563583" y="10579754"/>
            <a:ext cx="2031581" cy="377800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tsA</a:t>
            </a:r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: 933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2910127" y="10426478"/>
            <a:ext cx="805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142 </a:t>
            </a:r>
            <a:r>
              <a:rPr lang="en-AU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996606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9" name="Straight Connector 38"/>
          <p:cNvCxnSpPr/>
          <p:nvPr/>
        </p:nvCxnSpPr>
        <p:spPr>
          <a:xfrm flipV="1">
            <a:off x="782165" y="1213859"/>
            <a:ext cx="4659741" cy="3600"/>
          </a:xfrm>
          <a:prstGeom prst="line">
            <a:avLst/>
          </a:prstGeom>
          <a:solidFill>
            <a:schemeClr val="bg1"/>
          </a:solidFill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Right Arrow 39"/>
          <p:cNvSpPr/>
          <p:nvPr/>
        </p:nvSpPr>
        <p:spPr>
          <a:xfrm>
            <a:off x="3433657" y="999975"/>
            <a:ext cx="2182444" cy="405268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erR_spy0187_SF370: 465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Right Arrow 40"/>
          <p:cNvSpPr/>
          <p:nvPr/>
        </p:nvSpPr>
        <p:spPr>
          <a:xfrm>
            <a:off x="743953" y="1018320"/>
            <a:ext cx="2116622" cy="405268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A</a:t>
            </a:r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binding protein :  453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2860575" y="806961"/>
            <a:ext cx="805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51 </a:t>
            </a:r>
            <a:r>
              <a:rPr lang="en-AU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3" name="Straight Connector 42"/>
          <p:cNvCxnSpPr/>
          <p:nvPr/>
        </p:nvCxnSpPr>
        <p:spPr>
          <a:xfrm flipV="1">
            <a:off x="820377" y="2058003"/>
            <a:ext cx="4659741" cy="3600"/>
          </a:xfrm>
          <a:prstGeom prst="line">
            <a:avLst/>
          </a:prstGeom>
          <a:solidFill>
            <a:schemeClr val="bg1"/>
          </a:solidFill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Right Arrow 43"/>
          <p:cNvSpPr/>
          <p:nvPr/>
        </p:nvSpPr>
        <p:spPr>
          <a:xfrm>
            <a:off x="3263461" y="1844119"/>
            <a:ext cx="2390852" cy="405268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rgR_spy1870_SF370: 741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2594092" y="1605146"/>
            <a:ext cx="805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239 </a:t>
            </a:r>
            <a:r>
              <a:rPr lang="en-AU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Left Arrow 46"/>
          <p:cNvSpPr/>
          <p:nvPr/>
        </p:nvSpPr>
        <p:spPr>
          <a:xfrm>
            <a:off x="743953" y="1844119"/>
            <a:ext cx="1821978" cy="405268"/>
          </a:xfrm>
          <a:prstGeom prst="lef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dp</a:t>
            </a:r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: 777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8" name="Straight Connector 47"/>
          <p:cNvCxnSpPr/>
          <p:nvPr/>
        </p:nvCxnSpPr>
        <p:spPr>
          <a:xfrm flipV="1">
            <a:off x="765889" y="3003404"/>
            <a:ext cx="4659741" cy="3600"/>
          </a:xfrm>
          <a:prstGeom prst="line">
            <a:avLst/>
          </a:prstGeom>
          <a:solidFill>
            <a:schemeClr val="bg1"/>
          </a:solidFill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Right Arrow 48"/>
          <p:cNvSpPr/>
          <p:nvPr/>
        </p:nvSpPr>
        <p:spPr>
          <a:xfrm>
            <a:off x="3775445" y="2789520"/>
            <a:ext cx="1824380" cy="405268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luxS_SF370: 480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Right Arrow 49"/>
          <p:cNvSpPr/>
          <p:nvPr/>
        </p:nvSpPr>
        <p:spPr>
          <a:xfrm>
            <a:off x="727676" y="2793351"/>
            <a:ext cx="2873574" cy="405268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citrate transporter_spy1641:  1329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3372558" y="2547910"/>
            <a:ext cx="805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73 </a:t>
            </a:r>
            <a:r>
              <a:rPr lang="en-AU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2" name="Straight Connector 51"/>
          <p:cNvCxnSpPr/>
          <p:nvPr/>
        </p:nvCxnSpPr>
        <p:spPr>
          <a:xfrm flipV="1">
            <a:off x="797987" y="3833034"/>
            <a:ext cx="4659741" cy="3600"/>
          </a:xfrm>
          <a:prstGeom prst="line">
            <a:avLst/>
          </a:prstGeom>
          <a:solidFill>
            <a:schemeClr val="bg1"/>
          </a:solidFill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Right Arrow 52"/>
          <p:cNvSpPr/>
          <p:nvPr/>
        </p:nvSpPr>
        <p:spPr>
          <a:xfrm>
            <a:off x="2731180" y="3619150"/>
            <a:ext cx="3876390" cy="405268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gar ABC transporter substrate-binding protein : </a:t>
            </a:r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245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2269129" y="3465561"/>
            <a:ext cx="805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245 </a:t>
            </a:r>
            <a:r>
              <a:rPr lang="en-AU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Left Arrow 54"/>
          <p:cNvSpPr/>
          <p:nvPr/>
        </p:nvSpPr>
        <p:spPr>
          <a:xfrm>
            <a:off x="144483" y="3619150"/>
            <a:ext cx="2305471" cy="405268"/>
          </a:xfrm>
          <a:prstGeom prst="lef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lR_spy1293_SF370 </a:t>
            </a:r>
            <a:r>
              <a:rPr lang="en-AU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17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4" name="Straight Connector 33"/>
          <p:cNvCxnSpPr/>
          <p:nvPr/>
        </p:nvCxnSpPr>
        <p:spPr>
          <a:xfrm flipV="1">
            <a:off x="820377" y="4684609"/>
            <a:ext cx="4659741" cy="3600"/>
          </a:xfrm>
          <a:prstGeom prst="line">
            <a:avLst/>
          </a:prstGeom>
          <a:solidFill>
            <a:schemeClr val="bg1"/>
          </a:solidFill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Right Arrow 44"/>
          <p:cNvSpPr/>
          <p:nvPr/>
        </p:nvSpPr>
        <p:spPr>
          <a:xfrm>
            <a:off x="3089416" y="4470149"/>
            <a:ext cx="2399357" cy="405268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rv_spy1857_SF370 </a:t>
            </a:r>
            <a:r>
              <a:rPr lang="en-AU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717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2091835" y="4335337"/>
            <a:ext cx="805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105 </a:t>
            </a:r>
            <a:r>
              <a:rPr lang="en-AU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Left Arrow 56"/>
          <p:cNvSpPr/>
          <p:nvPr/>
        </p:nvSpPr>
        <p:spPr>
          <a:xfrm>
            <a:off x="743953" y="4470725"/>
            <a:ext cx="1316416" cy="405268"/>
          </a:xfrm>
          <a:prstGeom prst="lef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rA</a:t>
            </a:r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: 1194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6" name="Straight Connector 65"/>
          <p:cNvCxnSpPr/>
          <p:nvPr/>
        </p:nvCxnSpPr>
        <p:spPr>
          <a:xfrm flipV="1">
            <a:off x="843722" y="5426639"/>
            <a:ext cx="4659741" cy="3600"/>
          </a:xfrm>
          <a:prstGeom prst="line">
            <a:avLst/>
          </a:prstGeom>
          <a:solidFill>
            <a:schemeClr val="bg1"/>
          </a:solidFill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Right Arrow 66"/>
          <p:cNvSpPr/>
          <p:nvPr/>
        </p:nvSpPr>
        <p:spPr>
          <a:xfrm>
            <a:off x="3775445" y="5212755"/>
            <a:ext cx="2204078" cy="405268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spy0899 :  534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3165460" y="4961856"/>
            <a:ext cx="805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221 </a:t>
            </a:r>
            <a:r>
              <a:rPr lang="en-AU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Left Arrow 68"/>
          <p:cNvSpPr/>
          <p:nvPr/>
        </p:nvSpPr>
        <p:spPr>
          <a:xfrm>
            <a:off x="767298" y="5212755"/>
            <a:ext cx="2605260" cy="405268"/>
          </a:xfrm>
          <a:prstGeom prst="lef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psY_spy0898_SF370 : 903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0" name="Straight Connector 69"/>
          <p:cNvCxnSpPr/>
          <p:nvPr/>
        </p:nvCxnSpPr>
        <p:spPr>
          <a:xfrm flipV="1">
            <a:off x="897045" y="6205941"/>
            <a:ext cx="4659741" cy="3600"/>
          </a:xfrm>
          <a:prstGeom prst="line">
            <a:avLst/>
          </a:prstGeom>
          <a:solidFill>
            <a:schemeClr val="bg1"/>
          </a:solidFill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Right Arrow 70"/>
          <p:cNvSpPr/>
          <p:nvPr/>
        </p:nvSpPr>
        <p:spPr>
          <a:xfrm>
            <a:off x="3508855" y="5992057"/>
            <a:ext cx="2523991" cy="405268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esterase_spy1718 : 984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2627884" y="5757231"/>
            <a:ext cx="805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71 </a:t>
            </a:r>
            <a:r>
              <a:rPr lang="en-AU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Left Arrow 72"/>
          <p:cNvSpPr/>
          <p:nvPr/>
        </p:nvSpPr>
        <p:spPr>
          <a:xfrm>
            <a:off x="820621" y="5992057"/>
            <a:ext cx="1728391" cy="405268"/>
          </a:xfrm>
          <a:prstGeom prst="lef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pY_SF370 : 432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8" name="Straight Connector 57"/>
          <p:cNvCxnSpPr/>
          <p:nvPr/>
        </p:nvCxnSpPr>
        <p:spPr>
          <a:xfrm flipV="1">
            <a:off x="1054538" y="7070858"/>
            <a:ext cx="4659741" cy="3600"/>
          </a:xfrm>
          <a:prstGeom prst="line">
            <a:avLst/>
          </a:prstGeom>
          <a:solidFill>
            <a:schemeClr val="bg1"/>
          </a:solidFill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Right Arrow 58"/>
          <p:cNvSpPr/>
          <p:nvPr/>
        </p:nvSpPr>
        <p:spPr>
          <a:xfrm>
            <a:off x="4178331" y="6856974"/>
            <a:ext cx="2012008" cy="405268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toB_spy1637 : 1185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3300212" y="6662276"/>
            <a:ext cx="805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201 </a:t>
            </a:r>
            <a:r>
              <a:rPr lang="en-AU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Left Arrow 60"/>
          <p:cNvSpPr/>
          <p:nvPr/>
        </p:nvSpPr>
        <p:spPr>
          <a:xfrm>
            <a:off x="978114" y="6856974"/>
            <a:ext cx="2285347" cy="405268"/>
          </a:xfrm>
          <a:prstGeom prst="lef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toR_spy1634_SF370 : 894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2" name="Straight Connector 61"/>
          <p:cNvCxnSpPr/>
          <p:nvPr/>
        </p:nvCxnSpPr>
        <p:spPr>
          <a:xfrm flipV="1">
            <a:off x="970342" y="7986592"/>
            <a:ext cx="4659741" cy="3600"/>
          </a:xfrm>
          <a:prstGeom prst="line">
            <a:avLst/>
          </a:prstGeom>
          <a:solidFill>
            <a:schemeClr val="bg1"/>
          </a:solidFill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Box 62"/>
          <p:cNvSpPr txBox="1"/>
          <p:nvPr/>
        </p:nvSpPr>
        <p:spPr>
          <a:xfrm>
            <a:off x="3309808" y="7607339"/>
            <a:ext cx="7155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63 </a:t>
            </a:r>
            <a:r>
              <a:rPr lang="en-AU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Left Arrow 63"/>
          <p:cNvSpPr/>
          <p:nvPr/>
        </p:nvSpPr>
        <p:spPr>
          <a:xfrm>
            <a:off x="921207" y="7813811"/>
            <a:ext cx="2451351" cy="357674"/>
          </a:xfrm>
          <a:prstGeom prst="lef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gR_spy0627_SF370: 993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Left Arrow 64"/>
          <p:cNvSpPr/>
          <p:nvPr/>
        </p:nvSpPr>
        <p:spPr>
          <a:xfrm>
            <a:off x="3775444" y="7795123"/>
            <a:ext cx="2339201" cy="365448"/>
          </a:xfrm>
          <a:prstGeom prst="lef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ligohyaluronate</a:t>
            </a:r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yase</a:t>
            </a:r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: 1905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4" name="Straight Connector 73"/>
          <p:cNvCxnSpPr/>
          <p:nvPr/>
        </p:nvCxnSpPr>
        <p:spPr>
          <a:xfrm flipV="1">
            <a:off x="936290" y="8974135"/>
            <a:ext cx="4659741" cy="3600"/>
          </a:xfrm>
          <a:prstGeom prst="line">
            <a:avLst/>
          </a:prstGeom>
          <a:solidFill>
            <a:schemeClr val="bg1"/>
          </a:solidFill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Right Arrow 74"/>
          <p:cNvSpPr/>
          <p:nvPr/>
        </p:nvSpPr>
        <p:spPr>
          <a:xfrm>
            <a:off x="3246800" y="8760251"/>
            <a:ext cx="2523426" cy="405268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dcR_spy0092_SF370: 441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Right Arrow 75"/>
          <p:cNvSpPr/>
          <p:nvPr/>
        </p:nvSpPr>
        <p:spPr>
          <a:xfrm>
            <a:off x="898078" y="8764082"/>
            <a:ext cx="2116622" cy="405268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pen reading frame: 159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2843913" y="8522327"/>
            <a:ext cx="805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9 </a:t>
            </a:r>
            <a:r>
              <a:rPr lang="en-AU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8" name="Straight Connector 77"/>
          <p:cNvCxnSpPr/>
          <p:nvPr/>
        </p:nvCxnSpPr>
        <p:spPr>
          <a:xfrm flipV="1">
            <a:off x="955983" y="9835309"/>
            <a:ext cx="4659741" cy="3600"/>
          </a:xfrm>
          <a:prstGeom prst="line">
            <a:avLst/>
          </a:prstGeom>
          <a:solidFill>
            <a:schemeClr val="bg1"/>
          </a:solidFill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TextBox 78"/>
          <p:cNvSpPr txBox="1"/>
          <p:nvPr/>
        </p:nvSpPr>
        <p:spPr>
          <a:xfrm>
            <a:off x="3370807" y="9417087"/>
            <a:ext cx="7155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55 </a:t>
            </a:r>
            <a:r>
              <a:rPr lang="en-AU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Left Arrow 79"/>
          <p:cNvSpPr/>
          <p:nvPr/>
        </p:nvSpPr>
        <p:spPr>
          <a:xfrm>
            <a:off x="906848" y="9662528"/>
            <a:ext cx="2602007" cy="357674"/>
          </a:xfrm>
          <a:prstGeom prst="lef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ntR_spy1202_SF370: 723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Left Arrow 80"/>
          <p:cNvSpPr/>
          <p:nvPr/>
        </p:nvSpPr>
        <p:spPr>
          <a:xfrm>
            <a:off x="3773693" y="9643840"/>
            <a:ext cx="2326593" cy="365448"/>
          </a:xfrm>
          <a:prstGeom prst="lef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putative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lyD</a:t>
            </a:r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:  1431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2" name="Straight Connector 81"/>
          <p:cNvCxnSpPr/>
          <p:nvPr/>
        </p:nvCxnSpPr>
        <p:spPr>
          <a:xfrm flipV="1">
            <a:off x="994195" y="10721634"/>
            <a:ext cx="4659741" cy="3600"/>
          </a:xfrm>
          <a:prstGeom prst="line">
            <a:avLst/>
          </a:prstGeom>
          <a:solidFill>
            <a:schemeClr val="bg1"/>
          </a:solidFill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Right Arrow 82"/>
          <p:cNvSpPr/>
          <p:nvPr/>
        </p:nvSpPr>
        <p:spPr>
          <a:xfrm>
            <a:off x="3508855" y="10507750"/>
            <a:ext cx="2319276" cy="405268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ntR_spy0715_SF370: 720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Right Arrow 83"/>
          <p:cNvSpPr/>
          <p:nvPr/>
        </p:nvSpPr>
        <p:spPr>
          <a:xfrm>
            <a:off x="955983" y="10512240"/>
            <a:ext cx="2116622" cy="405268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dcA</a:t>
            </a:r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: 1545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2963688" y="10270756"/>
            <a:ext cx="805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47 </a:t>
            </a:r>
            <a:r>
              <a:rPr lang="en-AU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979433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6" name="Straight Connector 15"/>
          <p:cNvCxnSpPr/>
          <p:nvPr/>
        </p:nvCxnSpPr>
        <p:spPr>
          <a:xfrm flipV="1">
            <a:off x="958024" y="1927747"/>
            <a:ext cx="4659741" cy="3600"/>
          </a:xfrm>
          <a:prstGeom prst="line">
            <a:avLst/>
          </a:prstGeom>
          <a:solidFill>
            <a:schemeClr val="bg1"/>
          </a:solidFill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Right Arrow 16"/>
          <p:cNvSpPr/>
          <p:nvPr/>
        </p:nvSpPr>
        <p:spPr>
          <a:xfrm>
            <a:off x="3569834" y="1713863"/>
            <a:ext cx="2523991" cy="405268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etR_spy2177_SF370 : 531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096200" y="1477999"/>
            <a:ext cx="805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34 </a:t>
            </a:r>
            <a:r>
              <a:rPr lang="en-AU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Left Arrow 18"/>
          <p:cNvSpPr/>
          <p:nvPr/>
        </p:nvSpPr>
        <p:spPr>
          <a:xfrm>
            <a:off x="881600" y="1713863"/>
            <a:ext cx="2319247" cy="405268"/>
          </a:xfrm>
          <a:prstGeom prst="lef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hage infection protein : 2271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0" name="Straight Connector 19"/>
          <p:cNvCxnSpPr/>
          <p:nvPr/>
        </p:nvCxnSpPr>
        <p:spPr>
          <a:xfrm flipV="1">
            <a:off x="946493" y="4908713"/>
            <a:ext cx="4659741" cy="3600"/>
          </a:xfrm>
          <a:prstGeom prst="line">
            <a:avLst/>
          </a:prstGeom>
          <a:solidFill>
            <a:schemeClr val="bg1"/>
          </a:solidFill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3412018" y="4503750"/>
            <a:ext cx="7155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95 </a:t>
            </a:r>
            <a:r>
              <a:rPr lang="en-AU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Left Arrow 21"/>
          <p:cNvSpPr/>
          <p:nvPr/>
        </p:nvSpPr>
        <p:spPr>
          <a:xfrm>
            <a:off x="897358" y="4735932"/>
            <a:ext cx="2514660" cy="357674"/>
          </a:xfrm>
          <a:prstGeom prst="lef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tsR_spy2074_SF370 </a:t>
            </a:r>
            <a:r>
              <a:rPr lang="en-AU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:  459 </a:t>
            </a:r>
            <a:r>
              <a:rPr lang="en-AU" sz="12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Left Arrow 22"/>
          <p:cNvSpPr/>
          <p:nvPr/>
        </p:nvSpPr>
        <p:spPr>
          <a:xfrm>
            <a:off x="4061911" y="4717244"/>
            <a:ext cx="2028885" cy="365448"/>
          </a:xfrm>
          <a:prstGeom prst="lef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sp</a:t>
            </a:r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:  201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4" name="Straight Connector 23"/>
          <p:cNvCxnSpPr/>
          <p:nvPr/>
        </p:nvCxnSpPr>
        <p:spPr>
          <a:xfrm flipV="1">
            <a:off x="1071553" y="5926488"/>
            <a:ext cx="4659741" cy="3600"/>
          </a:xfrm>
          <a:prstGeom prst="line">
            <a:avLst/>
          </a:prstGeom>
          <a:solidFill>
            <a:schemeClr val="bg1"/>
          </a:solidFill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Right Arrow 24"/>
          <p:cNvSpPr/>
          <p:nvPr/>
        </p:nvSpPr>
        <p:spPr>
          <a:xfrm>
            <a:off x="4027391" y="5709472"/>
            <a:ext cx="2097924" cy="405268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fr_spy0887_SF370: 741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Right Arrow 25"/>
          <p:cNvSpPr/>
          <p:nvPr/>
        </p:nvSpPr>
        <p:spPr>
          <a:xfrm>
            <a:off x="728118" y="5720224"/>
            <a:ext cx="3079447" cy="405268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utative GTP-binding protein : 597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3619909" y="5438735"/>
            <a:ext cx="805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47 </a:t>
            </a:r>
            <a:r>
              <a:rPr lang="en-AU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8" name="Straight Connector 27"/>
          <p:cNvCxnSpPr/>
          <p:nvPr/>
        </p:nvCxnSpPr>
        <p:spPr>
          <a:xfrm flipV="1">
            <a:off x="776398" y="6913157"/>
            <a:ext cx="4659741" cy="3600"/>
          </a:xfrm>
          <a:prstGeom prst="line">
            <a:avLst/>
          </a:prstGeom>
          <a:solidFill>
            <a:schemeClr val="bg1"/>
          </a:solidFill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Right Arrow 28"/>
          <p:cNvSpPr/>
          <p:nvPr/>
        </p:nvSpPr>
        <p:spPr>
          <a:xfrm>
            <a:off x="3807565" y="6703104"/>
            <a:ext cx="2198316" cy="405268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vlg_spy0188_SF370:  297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Right Arrow 29"/>
          <p:cNvSpPr/>
          <p:nvPr/>
        </p:nvSpPr>
        <p:spPr>
          <a:xfrm>
            <a:off x="738185" y="6703104"/>
            <a:ext cx="2023801" cy="405268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erR_spy0187 </a:t>
            </a:r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: 465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2871084" y="6486169"/>
            <a:ext cx="805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155 </a:t>
            </a:r>
            <a:r>
              <a:rPr lang="en-AU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2" name="Straight Connector 31"/>
          <p:cNvCxnSpPr/>
          <p:nvPr/>
        </p:nvCxnSpPr>
        <p:spPr>
          <a:xfrm flipV="1">
            <a:off x="804542" y="3939271"/>
            <a:ext cx="4659741" cy="3600"/>
          </a:xfrm>
          <a:prstGeom prst="line">
            <a:avLst/>
          </a:prstGeom>
          <a:solidFill>
            <a:schemeClr val="bg1"/>
          </a:solidFill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Right Arrow 32"/>
          <p:cNvSpPr/>
          <p:nvPr/>
        </p:nvSpPr>
        <p:spPr>
          <a:xfrm>
            <a:off x="3416352" y="3725387"/>
            <a:ext cx="2523991" cy="405268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czA_SF370 :  519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2942718" y="3489523"/>
            <a:ext cx="805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35 </a:t>
            </a:r>
            <a:r>
              <a:rPr lang="en-AU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Left Arrow 34"/>
          <p:cNvSpPr/>
          <p:nvPr/>
        </p:nvSpPr>
        <p:spPr>
          <a:xfrm>
            <a:off x="728118" y="3725387"/>
            <a:ext cx="2319247" cy="405268"/>
          </a:xfrm>
          <a:prstGeom prst="lef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zcD_spy0845 :  873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6" name="Straight Connector 35"/>
          <p:cNvCxnSpPr/>
          <p:nvPr/>
        </p:nvCxnSpPr>
        <p:spPr>
          <a:xfrm flipV="1">
            <a:off x="824934" y="3025942"/>
            <a:ext cx="4659741" cy="3600"/>
          </a:xfrm>
          <a:prstGeom prst="line">
            <a:avLst/>
          </a:prstGeom>
          <a:solidFill>
            <a:schemeClr val="bg1"/>
          </a:solidFill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Right Arrow 36"/>
          <p:cNvSpPr/>
          <p:nvPr/>
        </p:nvSpPr>
        <p:spPr>
          <a:xfrm>
            <a:off x="4127525" y="2812057"/>
            <a:ext cx="1833210" cy="428997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etR_spy1258 :  540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3337535" y="2615148"/>
            <a:ext cx="805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117 </a:t>
            </a:r>
            <a:r>
              <a:rPr lang="en-AU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Left Arrow 38"/>
          <p:cNvSpPr/>
          <p:nvPr/>
        </p:nvSpPr>
        <p:spPr>
          <a:xfrm>
            <a:off x="748510" y="2812057"/>
            <a:ext cx="2590385" cy="428997"/>
          </a:xfrm>
          <a:prstGeom prst="lef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py1257_SF370 : 699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0" name="Straight Connector 39"/>
          <p:cNvCxnSpPr/>
          <p:nvPr/>
        </p:nvCxnSpPr>
        <p:spPr>
          <a:xfrm flipV="1">
            <a:off x="855248" y="7907287"/>
            <a:ext cx="4659741" cy="3600"/>
          </a:xfrm>
          <a:prstGeom prst="line">
            <a:avLst/>
          </a:prstGeom>
          <a:solidFill>
            <a:schemeClr val="bg1"/>
          </a:solidFill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Right Arrow 40"/>
          <p:cNvSpPr/>
          <p:nvPr/>
        </p:nvSpPr>
        <p:spPr>
          <a:xfrm>
            <a:off x="3467058" y="7693403"/>
            <a:ext cx="2523991" cy="405268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ka_SF370 :  1319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2993424" y="7457539"/>
            <a:ext cx="805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360 </a:t>
            </a:r>
            <a:r>
              <a:rPr lang="en-AU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Left Arrow 42"/>
          <p:cNvSpPr/>
          <p:nvPr/>
        </p:nvSpPr>
        <p:spPr>
          <a:xfrm>
            <a:off x="778824" y="7693403"/>
            <a:ext cx="2319247" cy="405268"/>
          </a:xfrm>
          <a:prstGeom prst="lef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rp_spy1978 :  846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4" name="Straight Connector 43"/>
          <p:cNvCxnSpPr/>
          <p:nvPr/>
        </p:nvCxnSpPr>
        <p:spPr>
          <a:xfrm flipV="1">
            <a:off x="880966" y="8897586"/>
            <a:ext cx="4659741" cy="3600"/>
          </a:xfrm>
          <a:prstGeom prst="line">
            <a:avLst/>
          </a:prstGeom>
          <a:solidFill>
            <a:schemeClr val="bg1"/>
          </a:solidFill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Right Arrow 44"/>
          <p:cNvSpPr/>
          <p:nvPr/>
        </p:nvSpPr>
        <p:spPr>
          <a:xfrm>
            <a:off x="3492776" y="8683702"/>
            <a:ext cx="2523991" cy="405268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py1603_SF370 : 1311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3019142" y="8447838"/>
            <a:ext cx="805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05 </a:t>
            </a:r>
            <a:r>
              <a:rPr lang="en-AU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Left Arrow 46"/>
          <p:cNvSpPr/>
          <p:nvPr/>
        </p:nvSpPr>
        <p:spPr>
          <a:xfrm>
            <a:off x="804542" y="8683702"/>
            <a:ext cx="2319247" cy="405268"/>
          </a:xfrm>
          <a:prstGeom prst="lef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ntR_spy1602 : 1038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8" name="Straight Connector 47"/>
          <p:cNvCxnSpPr/>
          <p:nvPr/>
        </p:nvCxnSpPr>
        <p:spPr>
          <a:xfrm flipV="1">
            <a:off x="872010" y="9713164"/>
            <a:ext cx="4659741" cy="3600"/>
          </a:xfrm>
          <a:prstGeom prst="line">
            <a:avLst/>
          </a:prstGeom>
          <a:solidFill>
            <a:schemeClr val="bg1"/>
          </a:solidFill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/>
          <p:cNvSpPr txBox="1"/>
          <p:nvPr/>
        </p:nvSpPr>
        <p:spPr>
          <a:xfrm>
            <a:off x="3337535" y="9308201"/>
            <a:ext cx="7155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34 </a:t>
            </a:r>
            <a:r>
              <a:rPr lang="en-AU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Left Arrow 49"/>
          <p:cNvSpPr/>
          <p:nvPr/>
        </p:nvSpPr>
        <p:spPr>
          <a:xfrm>
            <a:off x="822875" y="9540383"/>
            <a:ext cx="2514660" cy="357674"/>
          </a:xfrm>
          <a:prstGeom prst="lef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rcA_SF370 </a:t>
            </a:r>
            <a:r>
              <a:rPr lang="en-AU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:  </a:t>
            </a:r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32 </a:t>
            </a:r>
            <a:r>
              <a:rPr lang="en-AU" sz="12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Left Arrow 50"/>
          <p:cNvSpPr/>
          <p:nvPr/>
        </p:nvSpPr>
        <p:spPr>
          <a:xfrm>
            <a:off x="3987428" y="9521695"/>
            <a:ext cx="2028885" cy="365448"/>
          </a:xfrm>
          <a:prstGeom prst="lef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py1764 :  567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2" name="Straight Connector 51"/>
          <p:cNvCxnSpPr/>
          <p:nvPr/>
        </p:nvCxnSpPr>
        <p:spPr>
          <a:xfrm flipV="1">
            <a:off x="943089" y="10652630"/>
            <a:ext cx="4659741" cy="3600"/>
          </a:xfrm>
          <a:prstGeom prst="line">
            <a:avLst/>
          </a:prstGeom>
          <a:solidFill>
            <a:schemeClr val="bg1"/>
          </a:solidFill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52"/>
          <p:cNvSpPr txBox="1"/>
          <p:nvPr/>
        </p:nvSpPr>
        <p:spPr>
          <a:xfrm>
            <a:off x="3505941" y="10244067"/>
            <a:ext cx="7155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62 </a:t>
            </a:r>
            <a:r>
              <a:rPr lang="en-AU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Left Arrow 53"/>
          <p:cNvSpPr/>
          <p:nvPr/>
        </p:nvSpPr>
        <p:spPr>
          <a:xfrm>
            <a:off x="893954" y="10479849"/>
            <a:ext cx="2514660" cy="357674"/>
          </a:xfrm>
          <a:prstGeom prst="lef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rgA</a:t>
            </a:r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_SF370 : 639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Left Arrow 54"/>
          <p:cNvSpPr/>
          <p:nvPr/>
        </p:nvSpPr>
        <p:spPr>
          <a:xfrm>
            <a:off x="4058507" y="10461161"/>
            <a:ext cx="2028885" cy="365448"/>
          </a:xfrm>
          <a:prstGeom prst="lef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py1260 : 489 </a:t>
            </a:r>
            <a:r>
              <a:rPr lang="en-AU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endParaRPr lang="en-AU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033433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267</TotalTime>
  <Words>413</Words>
  <Application>Microsoft Office PowerPoint</Application>
  <PresentationFormat>Widescreen</PresentationFormat>
  <Paragraphs>105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>University of the Sunshine Coas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an Buckley</dc:creator>
  <cp:lastModifiedBy>Sean Buckley</cp:lastModifiedBy>
  <cp:revision>217</cp:revision>
  <cp:lastPrinted>2019-04-11T03:46:43Z</cp:lastPrinted>
  <dcterms:created xsi:type="dcterms:W3CDTF">2017-10-03T22:50:33Z</dcterms:created>
  <dcterms:modified xsi:type="dcterms:W3CDTF">2019-04-11T03:47:56Z</dcterms:modified>
</cp:coreProperties>
</file>